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3" r:id="rId3"/>
    <p:sldId id="258" r:id="rId4"/>
    <p:sldId id="262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sekvenace\jetel_ddradseq2018\distribuce%20frekvenci%20alel%20s%20coverage%20u%20vzorku\PCcorrelaceNfix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cs-CZ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674649306362859"/>
          <c:y val="0.10117247709151687"/>
          <c:w val="0.79650560854579855"/>
          <c:h val="0.80088861744626061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PCscorrelacesNfix!$AL$1</c:f>
              <c:strCache>
                <c:ptCount val="1"/>
                <c:pt idx="0">
                  <c:v>correlation Np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val>
            <c:numRef>
              <c:f>PCscorrelacesNfix!$AL$2:$AL$31</c:f>
              <c:numCache>
                <c:formatCode>General</c:formatCode>
                <c:ptCount val="30"/>
                <c:pt idx="0">
                  <c:v>-1.0687775657906469E-2</c:v>
                </c:pt>
                <c:pt idx="1">
                  <c:v>-0.29231600001054892</c:v>
                </c:pt>
                <c:pt idx="2">
                  <c:v>1.035736935027572E-2</c:v>
                </c:pt>
                <c:pt idx="3">
                  <c:v>2.5684307084484666E-3</c:v>
                </c:pt>
                <c:pt idx="4">
                  <c:v>4.2767654303096037E-2</c:v>
                </c:pt>
                <c:pt idx="5">
                  <c:v>0.13786678662662125</c:v>
                </c:pt>
                <c:pt idx="6">
                  <c:v>-0.33034502058916532</c:v>
                </c:pt>
                <c:pt idx="7">
                  <c:v>4.3571376046362152E-2</c:v>
                </c:pt>
                <c:pt idx="8">
                  <c:v>7.4925882359380289E-2</c:v>
                </c:pt>
                <c:pt idx="9">
                  <c:v>7.8695607493325201E-2</c:v>
                </c:pt>
                <c:pt idx="10">
                  <c:v>9.0194988928334857E-2</c:v>
                </c:pt>
                <c:pt idx="11">
                  <c:v>1.9213918737253088E-2</c:v>
                </c:pt>
                <c:pt idx="12">
                  <c:v>-3.4920524782735113E-3</c:v>
                </c:pt>
                <c:pt idx="13">
                  <c:v>-0.22101435508091241</c:v>
                </c:pt>
                <c:pt idx="14">
                  <c:v>3.9726522787110877E-2</c:v>
                </c:pt>
                <c:pt idx="15">
                  <c:v>3.2201981988591644E-2</c:v>
                </c:pt>
                <c:pt idx="16">
                  <c:v>4.5073665501787333E-2</c:v>
                </c:pt>
                <c:pt idx="17">
                  <c:v>-7.7800046210822593E-2</c:v>
                </c:pt>
                <c:pt idx="18">
                  <c:v>-5.3922511588734796E-2</c:v>
                </c:pt>
                <c:pt idx="19">
                  <c:v>2.954638660035391E-2</c:v>
                </c:pt>
                <c:pt idx="20">
                  <c:v>7.0208189530844636E-2</c:v>
                </c:pt>
                <c:pt idx="21">
                  <c:v>-0.14361260903723858</c:v>
                </c:pt>
                <c:pt idx="22">
                  <c:v>-8.5207829193885018E-2</c:v>
                </c:pt>
                <c:pt idx="23">
                  <c:v>7.5594314636634394E-2</c:v>
                </c:pt>
                <c:pt idx="24">
                  <c:v>2.0296752281742748E-2</c:v>
                </c:pt>
                <c:pt idx="25">
                  <c:v>-7.8631657285781559E-2</c:v>
                </c:pt>
                <c:pt idx="26">
                  <c:v>1.9978896474170541E-3</c:v>
                </c:pt>
                <c:pt idx="27">
                  <c:v>-0.11505758916468202</c:v>
                </c:pt>
                <c:pt idx="28">
                  <c:v>1.0588464246230314E-2</c:v>
                </c:pt>
                <c:pt idx="29">
                  <c:v>3.733968941567143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3A0-430B-8633-44A0400F3F24}"/>
            </c:ext>
          </c:extLst>
        </c:ser>
        <c:ser>
          <c:idx val="2"/>
          <c:order val="1"/>
          <c:tx>
            <c:strRef>
              <c:f>PCscorrelacesNfix!$AM$1</c:f>
              <c:strCache>
                <c:ptCount val="1"/>
                <c:pt idx="0">
                  <c:v>correlation Nfix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PCscorrelacesNfix!$AM$2:$AM$31</c:f>
              <c:numCache>
                <c:formatCode>General</c:formatCode>
                <c:ptCount val="30"/>
                <c:pt idx="0">
                  <c:v>-1.9812302501330901E-2</c:v>
                </c:pt>
                <c:pt idx="1">
                  <c:v>-8.6284026841846162E-2</c:v>
                </c:pt>
                <c:pt idx="2">
                  <c:v>-0.16686913679818019</c:v>
                </c:pt>
                <c:pt idx="3">
                  <c:v>6.0253659674398483E-2</c:v>
                </c:pt>
                <c:pt idx="4">
                  <c:v>9.0395503516310011E-2</c:v>
                </c:pt>
                <c:pt idx="5">
                  <c:v>0.10236443659428827</c:v>
                </c:pt>
                <c:pt idx="6">
                  <c:v>-0.20332800067832035</c:v>
                </c:pt>
                <c:pt idx="7">
                  <c:v>1.6207795320409727E-2</c:v>
                </c:pt>
                <c:pt idx="8">
                  <c:v>0.18388044162568845</c:v>
                </c:pt>
                <c:pt idx="9">
                  <c:v>-0.10756140695436776</c:v>
                </c:pt>
                <c:pt idx="10">
                  <c:v>-1.3544638657569524E-2</c:v>
                </c:pt>
                <c:pt idx="11">
                  <c:v>-0.13804914432998314</c:v>
                </c:pt>
                <c:pt idx="12">
                  <c:v>2.4161350189805426E-3</c:v>
                </c:pt>
                <c:pt idx="13">
                  <c:v>-5.4217910793204101E-2</c:v>
                </c:pt>
                <c:pt idx="14">
                  <c:v>-0.12369595445612361</c:v>
                </c:pt>
                <c:pt idx="15">
                  <c:v>6.2790499885991655E-2</c:v>
                </c:pt>
                <c:pt idx="16">
                  <c:v>-9.1473176999736047E-2</c:v>
                </c:pt>
                <c:pt idx="17">
                  <c:v>6.2889059584276333E-2</c:v>
                </c:pt>
                <c:pt idx="18">
                  <c:v>3.0267816111420157E-2</c:v>
                </c:pt>
                <c:pt idx="19">
                  <c:v>-0.13602745619041332</c:v>
                </c:pt>
                <c:pt idx="20">
                  <c:v>5.1415629408336494E-2</c:v>
                </c:pt>
                <c:pt idx="21">
                  <c:v>-0.22072844569170069</c:v>
                </c:pt>
                <c:pt idx="22">
                  <c:v>7.3348016729449947E-2</c:v>
                </c:pt>
                <c:pt idx="23">
                  <c:v>0.10541241946093795</c:v>
                </c:pt>
                <c:pt idx="24">
                  <c:v>6.5063959061708199E-2</c:v>
                </c:pt>
                <c:pt idx="25">
                  <c:v>-4.9267605924746667E-2</c:v>
                </c:pt>
                <c:pt idx="26">
                  <c:v>-4.8482949410213569E-2</c:v>
                </c:pt>
                <c:pt idx="27">
                  <c:v>-0.10472948645796046</c:v>
                </c:pt>
                <c:pt idx="28">
                  <c:v>6.8873504556628495E-2</c:v>
                </c:pt>
                <c:pt idx="29">
                  <c:v>-4.831470122515667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3A0-430B-8633-44A0400F3F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6"/>
        <c:axId val="187918976"/>
        <c:axId val="153580288"/>
      </c:barChart>
      <c:catAx>
        <c:axId val="1879189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cs-CZ"/>
                  <a:t>Principal</a:t>
                </a:r>
                <a:r>
                  <a:rPr lang="cs-CZ" baseline="0"/>
                  <a:t> Component</a:t>
                </a:r>
                <a:endParaRPr lang="en-GB"/>
              </a:p>
            </c:rich>
          </c:tx>
          <c:layout>
            <c:manualLayout>
              <c:xMode val="edge"/>
              <c:yMode val="edge"/>
              <c:x val="0.4241592347132131"/>
              <c:y val="0.8044813034960739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3580288"/>
        <c:crosses val="autoZero"/>
        <c:auto val="1"/>
        <c:lblAlgn val="ctr"/>
        <c:lblOffset val="100"/>
        <c:noMultiLvlLbl val="0"/>
      </c:catAx>
      <c:valAx>
        <c:axId val="153580288"/>
        <c:scaling>
          <c:orientation val="minMax"/>
          <c:max val="0.2"/>
          <c:min val="-0.35000000000000003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cs-CZ"/>
                  <a:t>Coefficient</a:t>
                </a:r>
                <a:r>
                  <a:rPr lang="cs-CZ" baseline="0"/>
                  <a:t> of correlation</a:t>
                </a:r>
                <a:endParaRPr lang="en-GB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79189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674852658545378"/>
          <c:y val="0.89976552357175643"/>
          <c:w val="0.4921195271448256"/>
          <c:h val="9.419546810067663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6350"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BA7F7F17-9039-4A2B-9C17-CC1AA13A72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Podnadpis 2">
            <a:extLst>
              <a:ext uri="{FF2B5EF4-FFF2-40B4-BE49-F238E27FC236}">
                <a16:creationId xmlns:a16="http://schemas.microsoft.com/office/drawing/2014/main" id="{3ADBB4B4-31DD-4839-9047-84EBCBD970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/>
              <a:t>Kliknutím můžete upravit styl předlohy.</a:t>
            </a:r>
            <a:endParaRPr lang="en-GB"/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0F9F2267-C931-4E45-A23B-9A23452295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01/11/2019</a:t>
            </a:fld>
            <a:endParaRPr lang="en-GB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C0F5D5DE-1EF0-4020-8F12-B2908D7AE8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F136303B-E688-4203-9EAA-BD94D3A7BD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559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AF50327A-2DBE-41A6-8387-838E53415D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1A4E67BD-82F4-4E1B-9C10-DB67FDC996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GB"/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F29C0B27-692C-4626-9DB5-521046BED8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01/11/2019</a:t>
            </a:fld>
            <a:endParaRPr lang="en-GB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8405C3E4-8E4E-4728-87A7-DD0C3C0B4A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0124CCC4-2816-4381-8866-D7C106F05B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5455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>
            <a:extLst>
              <a:ext uri="{FF2B5EF4-FFF2-40B4-BE49-F238E27FC236}">
                <a16:creationId xmlns:a16="http://schemas.microsoft.com/office/drawing/2014/main" id="{C9797D55-F289-4E4A-B293-E2060C3E58D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C9ACD967-A55D-4F46-9733-32E858AFFD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GB"/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C8E9BC74-1B18-4B0E-B60A-80D7F699F1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01/11/2019</a:t>
            </a:fld>
            <a:endParaRPr lang="en-GB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AAA7926F-E9F5-4D54-9E97-B3019937B5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EE34D0D1-18FD-4F55-9429-EB50DF69D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88889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42972943-C536-45A6-8902-0EE626B0BD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A5FBC489-DCB1-465E-A489-A6EE96718E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GB"/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549AF6C5-C44B-436D-B191-CE1F98274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01/11/2019</a:t>
            </a:fld>
            <a:endParaRPr lang="en-GB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20323D4E-DB87-445A-AFF8-4DF54A47D6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A8343F21-5C62-4681-99B8-BD8DCE5DDC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701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oddí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3FAA4BAE-13EB-4C2D-855B-AC3FA87D26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A46E4A25-9B1F-4AD8-B692-1D9CB3FF54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DCA177CF-2AC7-4857-A873-507547C382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01/11/2019</a:t>
            </a:fld>
            <a:endParaRPr lang="en-GB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EAE659E1-32E6-45A8-A82A-A586E73D0A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2FE6A916-07C6-45BE-AE2B-9D1A051ED3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74529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BB080A38-E2DD-49D7-9313-07C9675FE6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9E1FB1DB-062C-4E7D-807D-36C83B27D7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GB"/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7E4A7A18-89AB-4546-A220-E9ABA80F6A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GB"/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BE0215D5-ECBA-447D-B4B9-37234B9738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01/11/2019</a:t>
            </a:fld>
            <a:endParaRPr lang="en-GB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70A9CD83-FF83-4E0E-A98B-5355A620B0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CABF0996-9279-4EAC-B7D9-624C5FE6D8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83051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C1F1A3AC-F433-4663-9D18-AE23EE7EDE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A3CF8B0C-6765-48EA-B2A5-40F3A76D21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0B2B14AE-E1D1-4077-B9F9-4E5ED0AB74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GB"/>
          </a:p>
        </p:txBody>
      </p:sp>
      <p:sp>
        <p:nvSpPr>
          <p:cNvPr id="5" name="Zástupný text 4">
            <a:extLst>
              <a:ext uri="{FF2B5EF4-FFF2-40B4-BE49-F238E27FC236}">
                <a16:creationId xmlns:a16="http://schemas.microsoft.com/office/drawing/2014/main" id="{C02A552D-8B47-4BAD-955E-603FB1110F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6" name="Zástupný obsah 5">
            <a:extLst>
              <a:ext uri="{FF2B5EF4-FFF2-40B4-BE49-F238E27FC236}">
                <a16:creationId xmlns:a16="http://schemas.microsoft.com/office/drawing/2014/main" id="{61222E00-DFFF-4D38-BFF2-6F5527C73A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GB"/>
          </a:p>
        </p:txBody>
      </p:sp>
      <p:sp>
        <p:nvSpPr>
          <p:cNvPr id="7" name="Zástupný symbol pro datum 6">
            <a:extLst>
              <a:ext uri="{FF2B5EF4-FFF2-40B4-BE49-F238E27FC236}">
                <a16:creationId xmlns:a16="http://schemas.microsoft.com/office/drawing/2014/main" id="{8C4601D2-E0BF-4621-8D9F-04D811B78D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01/11/2019</a:t>
            </a:fld>
            <a:endParaRPr lang="en-GB"/>
          </a:p>
        </p:txBody>
      </p:sp>
      <p:sp>
        <p:nvSpPr>
          <p:cNvPr id="8" name="Zástupný symbol pro zápatí 7">
            <a:extLst>
              <a:ext uri="{FF2B5EF4-FFF2-40B4-BE49-F238E27FC236}">
                <a16:creationId xmlns:a16="http://schemas.microsoft.com/office/drawing/2014/main" id="{62B64B7D-29B9-4261-8E71-99D8449260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Zástupný symbol pro číslo snímku 8">
            <a:extLst>
              <a:ext uri="{FF2B5EF4-FFF2-40B4-BE49-F238E27FC236}">
                <a16:creationId xmlns:a16="http://schemas.microsoft.com/office/drawing/2014/main" id="{030E79F3-45E5-4FEF-942C-51A1DFD3A9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30888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12032B7F-8716-4D93-875E-2DA9E3ACA2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symbol pro datum 2">
            <a:extLst>
              <a:ext uri="{FF2B5EF4-FFF2-40B4-BE49-F238E27FC236}">
                <a16:creationId xmlns:a16="http://schemas.microsoft.com/office/drawing/2014/main" id="{456066FB-F463-4824-A01B-2A18ED1912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01/11/2019</a:t>
            </a:fld>
            <a:endParaRPr lang="en-GB"/>
          </a:p>
        </p:txBody>
      </p:sp>
      <p:sp>
        <p:nvSpPr>
          <p:cNvPr id="4" name="Zástupný symbol pro zápatí 3">
            <a:extLst>
              <a:ext uri="{FF2B5EF4-FFF2-40B4-BE49-F238E27FC236}">
                <a16:creationId xmlns:a16="http://schemas.microsoft.com/office/drawing/2014/main" id="{962242D3-6541-44F0-A257-F151E1A9D6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Zástupný symbol pro číslo snímku 4">
            <a:extLst>
              <a:ext uri="{FF2B5EF4-FFF2-40B4-BE49-F238E27FC236}">
                <a16:creationId xmlns:a16="http://schemas.microsoft.com/office/drawing/2014/main" id="{3EC7B352-B32F-489F-A5A1-AC3E18FF63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8796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>
            <a:extLst>
              <a:ext uri="{FF2B5EF4-FFF2-40B4-BE49-F238E27FC236}">
                <a16:creationId xmlns:a16="http://schemas.microsoft.com/office/drawing/2014/main" id="{B62A0EFD-7CB4-48FE-9B9E-0EE9B84D9D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01/11/2019</a:t>
            </a:fld>
            <a:endParaRPr lang="en-GB"/>
          </a:p>
        </p:txBody>
      </p:sp>
      <p:sp>
        <p:nvSpPr>
          <p:cNvPr id="3" name="Zástupný symbol pro zápatí 2">
            <a:extLst>
              <a:ext uri="{FF2B5EF4-FFF2-40B4-BE49-F238E27FC236}">
                <a16:creationId xmlns:a16="http://schemas.microsoft.com/office/drawing/2014/main" id="{77DB3AE3-3390-4A0A-9707-88209E9D51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Zástupný symbol pro číslo snímku 3">
            <a:extLst>
              <a:ext uri="{FF2B5EF4-FFF2-40B4-BE49-F238E27FC236}">
                <a16:creationId xmlns:a16="http://schemas.microsoft.com/office/drawing/2014/main" id="{78076962-EB37-4BED-AEBD-1DBE957F98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2918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B6BCA2A0-E334-4D36-862A-73AFB59D5A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F5E682E3-0AF6-44AC-9AA6-D7CEECED92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GB"/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1C804624-746B-4ED5-969F-C84EEA3609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15A3ABDF-5C84-43BD-87F1-AF6331EDE9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01/11/2019</a:t>
            </a:fld>
            <a:endParaRPr lang="en-GB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1E1DAE2B-CEAB-4569-941F-A96F80240F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CC2A7EBB-0128-44D9-A1AE-B9F69F61AC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5420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720C99B1-8B65-46F6-91C0-51EA6492B5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symbol obrázku 2">
            <a:extLst>
              <a:ext uri="{FF2B5EF4-FFF2-40B4-BE49-F238E27FC236}">
                <a16:creationId xmlns:a16="http://schemas.microsoft.com/office/drawing/2014/main" id="{7DECD4D1-B371-43B5-BBCE-AC561B83AD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CC054C41-CC8A-44BC-9856-D8A03F4610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C919E9DF-E69D-4B00-A6D7-5473491462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01/11/2019</a:t>
            </a:fld>
            <a:endParaRPr lang="en-GB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9E5C75FF-D26A-4FD7-A5C3-5D8F29330A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7E6404A1-92D2-4477-9B72-2C39A1724C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6932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nadpis 1">
            <a:extLst>
              <a:ext uri="{FF2B5EF4-FFF2-40B4-BE49-F238E27FC236}">
                <a16:creationId xmlns:a16="http://schemas.microsoft.com/office/drawing/2014/main" id="{DB7D1F6A-4A27-400A-B9CF-4871CAA3C8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946CDC22-BE10-45A2-BBB6-095CAAD0C5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GB"/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5617589D-CEE6-45C6-AF09-2348BD4F2E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0715B-6E96-4DF5-8A23-E36F318C3F06}" type="datetimeFigureOut">
              <a:rPr lang="en-GB" smtClean="0"/>
              <a:t>01/11/2019</a:t>
            </a:fld>
            <a:endParaRPr lang="en-GB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8715F050-7226-4CDE-B629-B238432F52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DAE6F16B-D3AD-4A19-BBDF-C5F4F32F11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7003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16B27AF2-D3F4-4F96-98E9-B33482BD1A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3999" y="1122363"/>
            <a:ext cx="9626353" cy="2387600"/>
          </a:xfrm>
        </p:spPr>
        <p:txBody>
          <a:bodyPr/>
          <a:lstStyle/>
          <a:p>
            <a:r>
              <a:rPr lang="cs-CZ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Suppl</a:t>
            </a:r>
            <a:r>
              <a:rPr lang="en-US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e</a:t>
            </a:r>
            <a:r>
              <a:rPr lang="cs-CZ" err="1">
                <a:latin typeface="Palatino Linotype" panose="02040502050505030304" pitchFamily="18" charset="0"/>
                <a:cs typeface="Times New Roman" panose="02020603050405020304" pitchFamily="18" charset="0"/>
              </a:rPr>
              <a:t>mentary</a:t>
            </a:r>
            <a:r>
              <a:rPr lang="cs-CZ">
                <a:latin typeface="Palatino Linotype" panose="02040502050505030304" pitchFamily="18" charset="0"/>
                <a:cs typeface="Times New Roman" panose="02020603050405020304" pitchFamily="18" charset="0"/>
              </a:rPr>
              <a:t> material figures </a:t>
            </a:r>
            <a:endParaRPr lang="en-GB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45592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Obrázek 4">
            <a:extLst>
              <a:ext uri="{FF2B5EF4-FFF2-40B4-BE49-F238E27FC236}">
                <a16:creationId xmlns:a16="http://schemas.microsoft.com/office/drawing/2014/main" id="{85450140-CF3C-4A82-B661-1CFFC077D7F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1821"/>
          <a:stretch/>
        </p:blipFill>
        <p:spPr>
          <a:xfrm>
            <a:off x="1264327" y="556826"/>
            <a:ext cx="4657636" cy="4269665"/>
          </a:xfrm>
          <a:prstGeom prst="rect">
            <a:avLst/>
          </a:prstGeom>
        </p:spPr>
      </p:pic>
      <p:pic>
        <p:nvPicPr>
          <p:cNvPr id="7" name="Obrázek 6">
            <a:extLst>
              <a:ext uri="{FF2B5EF4-FFF2-40B4-BE49-F238E27FC236}">
                <a16:creationId xmlns:a16="http://schemas.microsoft.com/office/drawing/2014/main" id="{D7659EAF-3EB3-4939-A890-BED603975AF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9" t="4943" r="2209" b="29402"/>
          <a:stretch/>
        </p:blipFill>
        <p:spPr>
          <a:xfrm>
            <a:off x="6482083" y="1031275"/>
            <a:ext cx="4847208" cy="3320766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3" name="TextovéPole 2">
            <a:extLst>
              <a:ext uri="{FF2B5EF4-FFF2-40B4-BE49-F238E27FC236}">
                <a16:creationId xmlns:a16="http://schemas.microsoft.com/office/drawing/2014/main" id="{4EEACA70-6032-4093-9176-BF5CAB92337C}"/>
              </a:ext>
            </a:extLst>
          </p:cNvPr>
          <p:cNvSpPr txBox="1"/>
          <p:nvPr/>
        </p:nvSpPr>
        <p:spPr>
          <a:xfrm>
            <a:off x="1193305" y="4826491"/>
            <a:ext cx="1043644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Palatino Linotype" panose="02040502050505030304" pitchFamily="18" charset="0"/>
              </a:rPr>
              <a:t>Figure S1</a:t>
            </a:r>
            <a:r>
              <a:rPr lang="en-US" b="1" dirty="0">
                <a:latin typeface="Palatino Linotype" panose="02040502050505030304" pitchFamily="18" charset="0"/>
              </a:rPr>
              <a:t>: </a:t>
            </a:r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) </a:t>
            </a:r>
            <a:r>
              <a:rPr lang="en-US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Mean</a:t>
            </a:r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equencing coverage per accession along targeted sequences from Panel 2. Different colors indicate different sequences. </a:t>
            </a:r>
            <a:r>
              <a:rPr lang="en-US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b) </a:t>
            </a:r>
            <a:r>
              <a:rPr lang="en-US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Example of variability of sequencing coverage along targeted sequence Tp_20815 among accessions. Different colors indicate different accessions.</a:t>
            </a:r>
          </a:p>
          <a:p>
            <a:endParaRPr lang="en-GB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ovéPole 3">
            <a:extLst>
              <a:ext uri="{FF2B5EF4-FFF2-40B4-BE49-F238E27FC236}">
                <a16:creationId xmlns:a16="http://schemas.microsoft.com/office/drawing/2014/main" id="{0B5E6578-3E01-45AC-8DA2-55EE828222E3}"/>
              </a:ext>
            </a:extLst>
          </p:cNvPr>
          <p:cNvSpPr txBox="1"/>
          <p:nvPr/>
        </p:nvSpPr>
        <p:spPr>
          <a:xfrm>
            <a:off x="1193305" y="525835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b="1">
                <a:latin typeface="Palatino Linotype" panose="02040502050505030304" pitchFamily="18" charset="0"/>
              </a:rPr>
              <a:t>a)</a:t>
            </a:r>
            <a:endParaRPr lang="en-GB" b="1">
              <a:latin typeface="Palatino Linotype" panose="02040502050505030304" pitchFamily="18" charset="0"/>
            </a:endParaRPr>
          </a:p>
        </p:txBody>
      </p:sp>
      <p:sp>
        <p:nvSpPr>
          <p:cNvPr id="8" name="TextovéPole 7">
            <a:extLst>
              <a:ext uri="{FF2B5EF4-FFF2-40B4-BE49-F238E27FC236}">
                <a16:creationId xmlns:a16="http://schemas.microsoft.com/office/drawing/2014/main" id="{A8EA9E0D-4A4E-419D-B46D-1F2B83C1795E}"/>
              </a:ext>
            </a:extLst>
          </p:cNvPr>
          <p:cNvSpPr txBox="1"/>
          <p:nvPr/>
        </p:nvSpPr>
        <p:spPr>
          <a:xfrm>
            <a:off x="6105057" y="525835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b="1">
                <a:latin typeface="Palatino Linotype" panose="02040502050505030304" pitchFamily="18" charset="0"/>
              </a:rPr>
              <a:t>b)</a:t>
            </a:r>
            <a:endParaRPr lang="en-GB" b="1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84151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Zástupný obsah 6">
            <a:extLst>
              <a:ext uri="{FF2B5EF4-FFF2-40B4-BE49-F238E27FC236}">
                <a16:creationId xmlns:a16="http://schemas.microsoft.com/office/drawing/2014/main" id="{19E5E872-DD34-4F84-89D5-6BAD8B96615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5060" y="1614010"/>
            <a:ext cx="4488401" cy="1765148"/>
          </a:xfrm>
        </p:spPr>
      </p:pic>
      <p:pic>
        <p:nvPicPr>
          <p:cNvPr id="9" name="Obrázek 8">
            <a:extLst>
              <a:ext uri="{FF2B5EF4-FFF2-40B4-BE49-F238E27FC236}">
                <a16:creationId xmlns:a16="http://schemas.microsoft.com/office/drawing/2014/main" id="{AED60B05-669E-487E-AE9B-8247539DE80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842"/>
          <a:stretch/>
        </p:blipFill>
        <p:spPr>
          <a:xfrm>
            <a:off x="7028155" y="1614010"/>
            <a:ext cx="2178400" cy="1696212"/>
          </a:xfrm>
          <a:prstGeom prst="rect">
            <a:avLst/>
          </a:prstGeom>
        </p:spPr>
      </p:pic>
      <p:sp>
        <p:nvSpPr>
          <p:cNvPr id="3" name="TextovéPole 2">
            <a:extLst>
              <a:ext uri="{FF2B5EF4-FFF2-40B4-BE49-F238E27FC236}">
                <a16:creationId xmlns:a16="http://schemas.microsoft.com/office/drawing/2014/main" id="{94F927F4-11A3-4718-A60C-96B0538AE91F}"/>
              </a:ext>
            </a:extLst>
          </p:cNvPr>
          <p:cNvSpPr txBox="1"/>
          <p:nvPr/>
        </p:nvSpPr>
        <p:spPr>
          <a:xfrm>
            <a:off x="2325950" y="3540680"/>
            <a:ext cx="764367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Palatino Linotype" panose="02040502050505030304" pitchFamily="18" charset="0"/>
              </a:rPr>
              <a:t>Figure S</a:t>
            </a:r>
            <a:r>
              <a:rPr lang="cs-CZ" b="1">
                <a:latin typeface="Palatino Linotype" panose="02040502050505030304" pitchFamily="18" charset="0"/>
              </a:rPr>
              <a:t>2</a:t>
            </a:r>
            <a:r>
              <a:rPr lang="en-US" b="1" dirty="0">
                <a:latin typeface="Palatino Linotype" panose="02040502050505030304" pitchFamily="18" charset="0"/>
              </a:rPr>
              <a:t>:</a:t>
            </a:r>
            <a:r>
              <a:rPr lang="en-US" dirty="0">
                <a:latin typeface="Palatino Linotype" panose="02040502050505030304" pitchFamily="18" charset="0"/>
              </a:rPr>
              <a:t> Panel 1 </a:t>
            </a:r>
            <a:r>
              <a:rPr lang="en-US" dirty="0" err="1">
                <a:latin typeface="Palatino Linotype" panose="02040502050505030304" pitchFamily="18" charset="0"/>
              </a:rPr>
              <a:t>InDel</a:t>
            </a:r>
            <a:r>
              <a:rPr lang="en-US" dirty="0">
                <a:latin typeface="Palatino Linotype" panose="02040502050505030304" pitchFamily="18" charset="0"/>
              </a:rPr>
              <a:t> validation. Validation of </a:t>
            </a:r>
            <a:r>
              <a:rPr lang="en-US" dirty="0" err="1">
                <a:latin typeface="Palatino Linotype" panose="02040502050505030304" pitchFamily="18" charset="0"/>
              </a:rPr>
              <a:t>InDels</a:t>
            </a:r>
            <a:r>
              <a:rPr lang="en-US" dirty="0">
                <a:latin typeface="Palatino Linotype" panose="02040502050505030304" pitchFamily="18" charset="0"/>
              </a:rPr>
              <a:t> CLE12_976, DNF2_419, DNF2_419b, PEN3_2917, CLE12_358, and EFD_1383. For each genotype analyzed, the presence of the reference or alternative allele is verified by product length.</a:t>
            </a:r>
          </a:p>
        </p:txBody>
      </p:sp>
    </p:spTree>
    <p:extLst>
      <p:ext uri="{BB962C8B-B14F-4D97-AF65-F5344CB8AC3E}">
        <p14:creationId xmlns:p14="http://schemas.microsoft.com/office/powerpoint/2010/main" val="10349171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 3">
            <a:extLst>
              <a:ext uri="{FF2B5EF4-FFF2-40B4-BE49-F238E27FC236}">
                <a16:creationId xmlns:a16="http://schemas.microsoft.com/office/drawing/2014/main" id="{0A5C3A44-991F-4E60-9CF2-C2F0E374310F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628749845"/>
              </p:ext>
            </p:extLst>
          </p:nvPr>
        </p:nvGraphicFramePr>
        <p:xfrm>
          <a:off x="2757366" y="629145"/>
          <a:ext cx="5625708" cy="27998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ovéPole 2">
            <a:extLst>
              <a:ext uri="{FF2B5EF4-FFF2-40B4-BE49-F238E27FC236}">
                <a16:creationId xmlns:a16="http://schemas.microsoft.com/office/drawing/2014/main" id="{3EE4E3A6-8533-436D-A282-CB03A28F1E1D}"/>
              </a:ext>
            </a:extLst>
          </p:cNvPr>
          <p:cNvSpPr txBox="1"/>
          <p:nvPr/>
        </p:nvSpPr>
        <p:spPr>
          <a:xfrm>
            <a:off x="2757366" y="3703784"/>
            <a:ext cx="553792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Palatino Linotype" panose="02040502050505030304" pitchFamily="18" charset="0"/>
              </a:rPr>
              <a:t>Figure S</a:t>
            </a:r>
            <a:r>
              <a:rPr lang="cs-CZ" b="1">
                <a:latin typeface="Palatino Linotype" panose="02040502050505030304" pitchFamily="18" charset="0"/>
              </a:rPr>
              <a:t>3</a:t>
            </a:r>
            <a:r>
              <a:rPr lang="en-US" b="1" dirty="0">
                <a:latin typeface="Palatino Linotype" panose="02040502050505030304" pitchFamily="18" charset="0"/>
              </a:rPr>
              <a:t>:</a:t>
            </a:r>
            <a:r>
              <a:rPr lang="en-US" dirty="0">
                <a:latin typeface="Palatino Linotype" panose="02040502050505030304" pitchFamily="18" charset="0"/>
              </a:rPr>
              <a:t> Correlation of phenotype and diversity pattern expressed in the first 30 PCs from principal component analysis. Bar plots show level of Pearson correlation coefficient of N content in leaves (orange) and </a:t>
            </a:r>
            <a:r>
              <a:rPr lang="en-US" baseline="30000" dirty="0">
                <a:latin typeface="Palatino Linotype" panose="02040502050505030304" pitchFamily="18" charset="0"/>
              </a:rPr>
              <a:t>15</a:t>
            </a:r>
            <a:r>
              <a:rPr lang="en-US" dirty="0">
                <a:latin typeface="Palatino Linotype" panose="02040502050505030304" pitchFamily="18" charset="0"/>
              </a:rPr>
              <a:t>N BNF rate (gray).</a:t>
            </a:r>
          </a:p>
        </p:txBody>
      </p:sp>
    </p:spTree>
    <p:extLst>
      <p:ext uri="{BB962C8B-B14F-4D97-AF65-F5344CB8AC3E}">
        <p14:creationId xmlns:p14="http://schemas.microsoft.com/office/powerpoint/2010/main" val="114603530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40</TotalTime>
  <Words>150</Words>
  <Application>Microsoft Office PowerPoint</Application>
  <PresentationFormat>Širokoúhlá obrazovka</PresentationFormat>
  <Paragraphs>8</Paragraphs>
  <Slides>4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4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Motiv Office</vt:lpstr>
      <vt:lpstr>Supplementary material figures </vt:lpstr>
      <vt:lpstr>Prezentace aplikace PowerPoint</vt:lpstr>
      <vt:lpstr>Prezentace aplikace PowerPoint</vt:lpstr>
      <vt:lpstr>Prezentace aplikac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Oldrich Trneny</dc:creator>
  <cp:lastModifiedBy>Oldrich Trneny</cp:lastModifiedBy>
  <cp:revision>36</cp:revision>
  <dcterms:created xsi:type="dcterms:W3CDTF">2019-09-03T09:39:05Z</dcterms:created>
  <dcterms:modified xsi:type="dcterms:W3CDTF">2019-11-01T12:46:16Z</dcterms:modified>
</cp:coreProperties>
</file>